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CDA93-06FA-4B09-8542-B7603FE78A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CA92F-3AE5-4905-A9EC-B737AB3C9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8BFF5-23E9-419F-B07B-4AA5BD4564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94920-2FF9-4B60-B3BA-0560B8E5FA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9A7F4-C426-4324-8B6A-212082B245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96C1D-50C9-4339-B56E-BF89BD3CDC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3CFE2-AE83-494B-AAE6-A32F1A89BB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AAFBC-33EF-46E4-9ADE-F48CD57274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D1F4E-86A9-4777-8B08-FD0C99DEA8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0FDEE-A51E-4C8F-8B68-68AF93D4CF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27C33-07A0-4339-A1F3-3286DC45E4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C9B09-AFE1-48E2-A0A8-2E3AAFB972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F8A777-C3FC-46BB-88C5-89435879D277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51800" y="684360"/>
            <a:ext cx="735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ig. S2   CT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908000" y="2768760"/>
            <a:ext cx="2948040" cy="2640960"/>
            <a:chOff x="1908000" y="2768760"/>
            <a:chExt cx="2948040" cy="2640960"/>
          </a:xfrm>
        </p:grpSpPr>
        <p:sp>
          <p:nvSpPr>
            <p:cNvPr id="43" name=""/>
            <p:cNvSpPr/>
            <p:nvPr/>
          </p:nvSpPr>
          <p:spPr>
            <a:xfrm>
              <a:off x="1931760" y="4236840"/>
              <a:ext cx="1220760" cy="1172880"/>
            </a:xfrm>
            <a:custGeom>
              <a:avLst/>
              <a:gdLst/>
              <a:ahLst/>
              <a:rect l="l" t="t" r="r" b="b"/>
              <a:pathLst>
                <a:path w="769" h="739">
                  <a:moveTo>
                    <a:pt x="133" y="8"/>
                  </a:moveTo>
                  <a:cubicBezTo>
                    <a:pt x="122" y="8"/>
                    <a:pt x="88" y="0"/>
                    <a:pt x="69" y="6"/>
                  </a:cubicBezTo>
                  <a:cubicBezTo>
                    <a:pt x="50" y="12"/>
                    <a:pt x="28" y="26"/>
                    <a:pt x="17" y="44"/>
                  </a:cubicBezTo>
                  <a:cubicBezTo>
                    <a:pt x="6" y="62"/>
                    <a:pt x="0" y="74"/>
                    <a:pt x="5" y="116"/>
                  </a:cubicBezTo>
                  <a:cubicBezTo>
                    <a:pt x="10" y="158"/>
                    <a:pt x="13" y="229"/>
                    <a:pt x="45" y="294"/>
                  </a:cubicBezTo>
                  <a:cubicBezTo>
                    <a:pt x="77" y="359"/>
                    <a:pt x="132" y="441"/>
                    <a:pt x="199" y="506"/>
                  </a:cubicBezTo>
                  <a:cubicBezTo>
                    <a:pt x="266" y="571"/>
                    <a:pt x="360" y="643"/>
                    <a:pt x="445" y="682"/>
                  </a:cubicBezTo>
                  <a:cubicBezTo>
                    <a:pt x="530" y="721"/>
                    <a:pt x="655" y="737"/>
                    <a:pt x="709" y="738"/>
                  </a:cubicBezTo>
                  <a:cubicBezTo>
                    <a:pt x="763" y="739"/>
                    <a:pt x="766" y="712"/>
                    <a:pt x="769" y="686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194000" y="3355560"/>
              <a:ext cx="24120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241440" y="5197320"/>
              <a:ext cx="217440" cy="914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"/>
            <p:cNvGrpSpPr/>
            <p:nvPr/>
          </p:nvGrpSpPr>
          <p:grpSpPr>
            <a:xfrm>
              <a:off x="2323800" y="3066840"/>
              <a:ext cx="2154240" cy="2113920"/>
              <a:chOff x="2323800" y="3066840"/>
              <a:chExt cx="2154240" cy="2113920"/>
            </a:xfrm>
          </p:grpSpPr>
          <p:sp>
            <p:nvSpPr>
              <p:cNvPr id="47" name=""/>
              <p:cNvSpPr/>
              <p:nvPr/>
            </p:nvSpPr>
            <p:spPr>
              <a:xfrm>
                <a:off x="3219120" y="3110760"/>
                <a:ext cx="190440" cy="31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352320" y="3075840"/>
                <a:ext cx="57240" cy="35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 flipH="1">
                <a:off x="3472920" y="3066840"/>
                <a:ext cx="12600" cy="267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H="1">
                <a:off x="3473280" y="3099600"/>
                <a:ext cx="142560" cy="23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409560" y="3428280"/>
                <a:ext cx="19080" cy="4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H="1">
                <a:off x="3430080" y="3334680"/>
                <a:ext cx="43200" cy="13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757320" y="3152160"/>
                <a:ext cx="11160" cy="209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H="1">
                <a:off x="3771360" y="3171240"/>
                <a:ext cx="82440" cy="185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H="1">
                <a:off x="3763440" y="3357000"/>
                <a:ext cx="5040" cy="63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H="1">
                <a:off x="3774600" y="3220560"/>
                <a:ext cx="169920" cy="191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H="1">
                <a:off x="3776040" y="3310920"/>
                <a:ext cx="228600" cy="102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H="1">
                <a:off x="3477600" y="3414240"/>
                <a:ext cx="290520" cy="43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425400" y="3463200"/>
                <a:ext cx="55800" cy="37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H="1">
                <a:off x="3415680" y="3837960"/>
                <a:ext cx="65160" cy="272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H="1">
                <a:off x="4034880" y="3399840"/>
                <a:ext cx="137880" cy="232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H="1">
                <a:off x="4030200" y="3520440"/>
                <a:ext cx="262080" cy="11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>
                <a:off x="3415680" y="3637800"/>
                <a:ext cx="615960" cy="482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H="1">
                <a:off x="3406320" y="4110840"/>
                <a:ext cx="7920" cy="1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018960" y="3120480"/>
                <a:ext cx="233640" cy="81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815920" y="3214080"/>
                <a:ext cx="436680" cy="72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634840" y="3339360"/>
                <a:ext cx="555840" cy="595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509560" y="3519000"/>
                <a:ext cx="676080" cy="41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187440" y="3934800"/>
                <a:ext cx="10296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252600" y="3934800"/>
                <a:ext cx="3780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390400" y="3710880"/>
                <a:ext cx="385920" cy="23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323800" y="3911040"/>
                <a:ext cx="45252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V="1">
                <a:off x="2328480" y="4015440"/>
                <a:ext cx="623880" cy="11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773080" y="3944160"/>
                <a:ext cx="181080" cy="69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952360" y="4011120"/>
                <a:ext cx="411120" cy="9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287520" y="4014000"/>
                <a:ext cx="83880" cy="95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368160" y="4104720"/>
                <a:ext cx="3672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>
                <a:off x="3405960" y="3709440"/>
                <a:ext cx="986040" cy="42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3404880" y="3901320"/>
                <a:ext cx="1071360" cy="231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401640" y="4133160"/>
                <a:ext cx="1440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H="1">
                <a:off x="3409560" y="4120560"/>
                <a:ext cx="1068480" cy="3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047840" y="4325400"/>
                <a:ext cx="41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047840" y="4325400"/>
                <a:ext cx="358560" cy="17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H="1" flipV="1">
                <a:off x="3425040" y="4156920"/>
                <a:ext cx="622440" cy="16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H="1" flipV="1">
                <a:off x="3414240" y="4177440"/>
                <a:ext cx="928800" cy="51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H="1">
                <a:off x="3382560" y="4176000"/>
                <a:ext cx="2880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H="1">
                <a:off x="3028320" y="4228560"/>
                <a:ext cx="352440" cy="13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H="1" flipV="1">
                <a:off x="2754000" y="4347360"/>
                <a:ext cx="27144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 flipH="1" flipV="1">
                <a:off x="2666520" y="4339080"/>
                <a:ext cx="85680" cy="6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H="1" flipV="1">
                <a:off x="2462040" y="4304520"/>
                <a:ext cx="201600" cy="3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flipH="1">
                <a:off x="2437560" y="4344480"/>
                <a:ext cx="225720" cy="5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2457000" y="4348800"/>
                <a:ext cx="297000" cy="15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V="1">
                <a:off x="2533320" y="4558680"/>
                <a:ext cx="173160" cy="2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2523600" y="4561920"/>
                <a:ext cx="185760" cy="12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flipV="1">
                <a:off x="2709360" y="4538160"/>
                <a:ext cx="61920" cy="1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H="1">
                <a:off x="2596320" y="4538160"/>
                <a:ext cx="181080" cy="21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V="1">
                <a:off x="2777760" y="4423320"/>
                <a:ext cx="193680" cy="10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H="1">
                <a:off x="2968200" y="4365000"/>
                <a:ext cx="60480" cy="58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flipH="1">
                <a:off x="2810880" y="4423680"/>
                <a:ext cx="160200" cy="29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H="1">
                <a:off x="2675880" y="4714200"/>
                <a:ext cx="135000" cy="9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flipH="1">
                <a:off x="2744280" y="4716000"/>
                <a:ext cx="66960" cy="14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H="1">
                <a:off x="3276360" y="4223520"/>
                <a:ext cx="109440" cy="31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H="1">
                <a:off x="3176280" y="4533120"/>
                <a:ext cx="101520" cy="64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H="1">
                <a:off x="3244680" y="4530240"/>
                <a:ext cx="33120" cy="4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H="1">
                <a:off x="2997000" y="4577760"/>
                <a:ext cx="247680" cy="528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H="1">
                <a:off x="2824920" y="4575960"/>
                <a:ext cx="419400" cy="438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382560" y="4225320"/>
                <a:ext cx="46080" cy="94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425400" y="4323600"/>
                <a:ext cx="22320" cy="563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447720" y="4887360"/>
                <a:ext cx="190440" cy="259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H="1">
                <a:off x="3446280" y="4882680"/>
                <a:ext cx="1440" cy="31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444480" y="4911120"/>
                <a:ext cx="55440" cy="256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H="1">
                <a:off x="3367800" y="4911120"/>
                <a:ext cx="79560" cy="26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428640" y="4315680"/>
                <a:ext cx="77760" cy="7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499920" y="4387320"/>
                <a:ext cx="228600" cy="350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725640" y="4734720"/>
                <a:ext cx="323640" cy="176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728520" y="4734720"/>
                <a:ext cx="3348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758760" y="4809600"/>
                <a:ext cx="204840" cy="18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762000" y="4815720"/>
                <a:ext cx="6480" cy="4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771720" y="4863600"/>
                <a:ext cx="1440" cy="19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769920" y="4863600"/>
                <a:ext cx="119160" cy="218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504960" y="4390560"/>
                <a:ext cx="652320" cy="40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" name=""/>
            <p:cNvSpPr/>
            <p:nvPr/>
          </p:nvSpPr>
          <p:spPr>
            <a:xfrm>
              <a:off x="4505040" y="4070160"/>
              <a:ext cx="1936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7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635280" y="5076360"/>
              <a:ext cx="326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MA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163600" y="4346280"/>
              <a:ext cx="23796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570200" y="5251320"/>
              <a:ext cx="235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060440" y="4881240"/>
              <a:ext cx="22068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947760" y="5016240"/>
              <a:ext cx="514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913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565440" y="5184360"/>
              <a:ext cx="19656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841560" y="5181480"/>
              <a:ext cx="1951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455640" y="5302080"/>
              <a:ext cx="20664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822400" y="5276520"/>
              <a:ext cx="563400" cy="91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48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898720" y="5146200"/>
              <a:ext cx="230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695320" y="5030640"/>
              <a:ext cx="1969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8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633400" y="4882680"/>
              <a:ext cx="1954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5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193840" y="4829040"/>
              <a:ext cx="48564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605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149200" y="4744800"/>
              <a:ext cx="48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41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295360" y="4651200"/>
              <a:ext cx="1951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009520" y="4447800"/>
              <a:ext cx="487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324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222280" y="4231800"/>
              <a:ext cx="21924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7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104920" y="4079520"/>
              <a:ext cx="19512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9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144520" y="3865320"/>
              <a:ext cx="195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908000" y="3659040"/>
              <a:ext cx="54144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576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333520" y="3409560"/>
              <a:ext cx="1936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730240" y="3020760"/>
              <a:ext cx="493920" cy="1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60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471400" y="3225600"/>
              <a:ext cx="1954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701800" y="3109680"/>
              <a:ext cx="214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252600" y="2971440"/>
              <a:ext cx="22068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004920" y="2908080"/>
              <a:ext cx="23976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5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381120" y="2846160"/>
              <a:ext cx="306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E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516120" y="2941200"/>
              <a:ext cx="49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5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931920" y="3030120"/>
              <a:ext cx="478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909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966840" y="3122280"/>
              <a:ext cx="2365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020840" y="3246120"/>
              <a:ext cx="26352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1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363920" y="4660560"/>
              <a:ext cx="492120" cy="8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358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493880" y="3825720"/>
              <a:ext cx="2383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0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317840" y="3477960"/>
              <a:ext cx="21744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490640" y="4279680"/>
              <a:ext cx="2383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4431960" y="4470120"/>
              <a:ext cx="26208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10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643200" y="3030120"/>
              <a:ext cx="29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E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414680" y="3661920"/>
              <a:ext cx="23796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257200" y="4533480"/>
              <a:ext cx="26352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1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186080" y="4767120"/>
              <a:ext cx="31896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MA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611600" y="5108400"/>
              <a:ext cx="158760" cy="12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773160" y="4881240"/>
              <a:ext cx="719280" cy="485280"/>
            </a:xfrm>
            <a:custGeom>
              <a:avLst/>
              <a:gdLst/>
              <a:ahLst/>
              <a:rect l="l" t="t" r="r" b="b"/>
              <a:pathLst>
                <a:path w="453" h="306">
                  <a:moveTo>
                    <a:pt x="1" y="214"/>
                  </a:moveTo>
                  <a:cubicBezTo>
                    <a:pt x="6" y="228"/>
                    <a:pt x="0" y="286"/>
                    <a:pt x="35" y="296"/>
                  </a:cubicBezTo>
                  <a:cubicBezTo>
                    <a:pt x="70" y="306"/>
                    <a:pt x="149" y="294"/>
                    <a:pt x="213" y="272"/>
                  </a:cubicBezTo>
                  <a:cubicBezTo>
                    <a:pt x="277" y="250"/>
                    <a:pt x="385" y="200"/>
                    <a:pt x="419" y="166"/>
                  </a:cubicBezTo>
                  <a:cubicBezTo>
                    <a:pt x="453" y="132"/>
                    <a:pt x="429" y="96"/>
                    <a:pt x="415" y="68"/>
                  </a:cubicBezTo>
                  <a:cubicBezTo>
                    <a:pt x="401" y="40"/>
                    <a:pt x="352" y="14"/>
                    <a:pt x="335" y="0"/>
                  </a:cubicBezTo>
                </a:path>
              </a:pathLst>
            </a:custGeom>
            <a:noFill/>
            <a:ln w="9360">
              <a:solidFill>
                <a:srgbClr val="0000cc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071520" y="2768760"/>
              <a:ext cx="1276560" cy="442440"/>
            </a:xfrm>
            <a:custGeom>
              <a:avLst/>
              <a:gdLst/>
              <a:ahLst/>
              <a:rect l="l" t="t" r="r" b="b"/>
              <a:pathLst>
                <a:path w="803" h="279">
                  <a:moveTo>
                    <a:pt x="27" y="67"/>
                  </a:moveTo>
                  <a:cubicBezTo>
                    <a:pt x="31" y="60"/>
                    <a:pt x="0" y="33"/>
                    <a:pt x="51" y="23"/>
                  </a:cubicBezTo>
                  <a:cubicBezTo>
                    <a:pt x="102" y="13"/>
                    <a:pt x="242" y="0"/>
                    <a:pt x="332" y="9"/>
                  </a:cubicBezTo>
                  <a:cubicBezTo>
                    <a:pt x="422" y="18"/>
                    <a:pt x="518" y="47"/>
                    <a:pt x="590" y="75"/>
                  </a:cubicBezTo>
                  <a:cubicBezTo>
                    <a:pt x="662" y="103"/>
                    <a:pt x="730" y="150"/>
                    <a:pt x="765" y="179"/>
                  </a:cubicBezTo>
                  <a:cubicBezTo>
                    <a:pt x="800" y="208"/>
                    <a:pt x="803" y="230"/>
                    <a:pt x="801" y="247"/>
                  </a:cubicBezTo>
                  <a:cubicBezTo>
                    <a:pt x="799" y="264"/>
                    <a:pt x="761" y="272"/>
                    <a:pt x="751" y="279"/>
                  </a:cubicBezTo>
                </a:path>
              </a:pathLst>
            </a:custGeom>
            <a:noFill/>
            <a:ln w="9360">
              <a:solidFill>
                <a:srgbClr val="6633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059000" y="5241600"/>
              <a:ext cx="347760" cy="101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8360" rIns="1836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cc"/>
                  </a:solidFill>
                  <a:latin typeface="Arial"/>
                  <a:ea typeface="宋体"/>
                </a:rPr>
                <a:t>CTL M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681360" y="2793600"/>
              <a:ext cx="330120" cy="11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8360" rIns="18360" tIns="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663300"/>
                  </a:solidFill>
                  <a:latin typeface="Arial"/>
                  <a:ea typeface="宋体"/>
                </a:rPr>
                <a:t>Select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168280" y="5035320"/>
              <a:ext cx="339840" cy="101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8360" rIns="1836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TL G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flipH="1" flipV="1" rot="20765400">
              <a:off x="2677320" y="4503960"/>
              <a:ext cx="4320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H="1" flipV="1" rot="7356600">
              <a:off x="3275280" y="4523400"/>
              <a:ext cx="42480" cy="478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11015400">
              <a:off x="2739600" y="4296960"/>
              <a:ext cx="428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14020800">
              <a:off x="3251880" y="389772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11990400">
              <a:off x="2942280" y="396468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rot="11116200">
              <a:off x="2652120" y="4293360"/>
              <a:ext cx="428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3348000">
              <a:off x="3138120" y="392220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H="1" flipV="1" rot="2737800">
              <a:off x="3425760" y="426636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H="1" flipV="1" rot="20011800">
              <a:off x="2749320" y="4486320"/>
              <a:ext cx="4140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10329000">
              <a:off x="3005640" y="430920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H="1" flipV="1" rot="12951000">
              <a:off x="3247200" y="4006440"/>
              <a:ext cx="410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8996000">
              <a:off x="3766680" y="3417120"/>
              <a:ext cx="442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H="1" flipV="1" rot="2293800">
              <a:off x="2770560" y="390564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rot="3243000">
              <a:off x="3356640" y="341460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rot="8583600">
              <a:off x="3345480" y="418356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rot="17006400">
              <a:off x="3477240" y="3316320"/>
              <a:ext cx="42480" cy="478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rot="16579800">
              <a:off x="3439080" y="3449520"/>
              <a:ext cx="42480" cy="478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rot="6060000">
              <a:off x="3719160" y="3323520"/>
              <a:ext cx="42480" cy="460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H="1" flipV="1" rot="7441200">
              <a:off x="2814120" y="4696920"/>
              <a:ext cx="42480" cy="460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H="1" flipV="1" rot="9121200">
              <a:off x="4025880" y="3636000"/>
              <a:ext cx="428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rot="17508000">
              <a:off x="3487680" y="382536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H="1" flipV="1" rot="17166000">
              <a:off x="3397680" y="486108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H="1" flipV="1" rot="13490400">
              <a:off x="3686400" y="4730400"/>
              <a:ext cx="4140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H="1" flipV="1" rot="2831400">
              <a:off x="3498480" y="434520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H="1" flipV="1" rot="12129600">
              <a:off x="4019760" y="432504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H="1" flipV="1" rot="7441200">
              <a:off x="2967480" y="4414680"/>
              <a:ext cx="42480" cy="478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809800" y="4322520"/>
              <a:ext cx="5688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806560" y="4470120"/>
              <a:ext cx="58680" cy="6012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823840" y="4608360"/>
              <a:ext cx="5868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276360" y="4422600"/>
              <a:ext cx="5868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417840" y="4782960"/>
              <a:ext cx="5688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646440" y="4630320"/>
              <a:ext cx="56880" cy="6012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897000" y="3688920"/>
              <a:ext cx="58680" cy="6012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3692160" y="3446280"/>
              <a:ext cx="5904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414600" y="3558960"/>
              <a:ext cx="60120" cy="5976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000240" y="4001760"/>
              <a:ext cx="60120" cy="60120"/>
            </a:xfrm>
            <a:prstGeom prst="ellipse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3T20:47:33Z</dcterms:created>
  <dc:creator>haobo</dc:creator>
  <dc:description/>
  <dc:language>en-US</dc:language>
  <cp:lastModifiedBy>Haobo Jiang</cp:lastModifiedBy>
  <dcterms:modified xsi:type="dcterms:W3CDTF">2007-08-08T18:27:43Z</dcterms:modified>
  <cp:revision>102</cp:revision>
  <dc:subject/>
  <dc:title>Slide 1</dc:title>
</cp:coreProperties>
</file>